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4650"/>
  </p:normalViewPr>
  <p:slideViewPr>
    <p:cSldViewPr snapToGrid="0" snapToObjects="1">
      <p:cViewPr>
        <p:scale>
          <a:sx n="1" d="2"/>
          <a:sy n="1" d="2"/>
        </p:scale>
        <p:origin x="-342" y="-118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8EDF64C-9C3E-EE48-9848-8E9413FAC97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655B499D-7DD3-AE47-A39B-280CFDE2011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FACAE76-74CD-0F42-AC3B-D266F0211F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6905CF-B80C-CC40-B8A8-3E567607DEA0}" type="datetimeFigureOut">
              <a:rPr lang="en-US" smtClean="0"/>
              <a:t>1/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56C5354-B7AA-4840-8E94-B206D154A4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7103E5B-C6A9-224B-B240-2B32A12761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DE812-7233-5143-83BF-B2D833500F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69039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5708D36-D02E-7340-B108-C5C5E1CECE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F8D5E542-6734-BB46-86E5-02FE399641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601ECB1-477D-024A-95B3-CB2DE6C77F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6905CF-B80C-CC40-B8A8-3E567607DEA0}" type="datetimeFigureOut">
              <a:rPr lang="en-US" smtClean="0"/>
              <a:t>1/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361E600-C178-7542-986F-E6E453F70E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9A1A500-97A5-C64F-8B0C-CDE28C1A7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DE812-7233-5143-83BF-B2D833500F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6434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F4721FA6-FC32-AB41-9B97-C327F151EE6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BC8E6B51-FC8B-F642-8676-0C1C1BC3A9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6A53829-A19D-2B47-A057-6E0EE8DFA8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6905CF-B80C-CC40-B8A8-3E567607DEA0}" type="datetimeFigureOut">
              <a:rPr lang="en-US" smtClean="0"/>
              <a:t>1/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A27B4DB-5A09-B84A-A1B9-EE05B852E8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83465CE-1FD6-4C4F-8FCA-1D79A48341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DE812-7233-5143-83BF-B2D833500F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013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BD56F47-C969-654F-B7D6-0272A5E536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23FFE28A-EB55-2A43-B5EC-61A36EF999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91F2EC9-0415-3049-9AF3-B5E8F70A0D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6905CF-B80C-CC40-B8A8-3E567607DEA0}" type="datetimeFigureOut">
              <a:rPr lang="en-US" smtClean="0"/>
              <a:t>1/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860038F-7D50-6245-A22B-6926DFB3B1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13D4D40-90EC-6641-A024-73925B3A6E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DE812-7233-5143-83BF-B2D833500F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96927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23CCDAA-BF79-F746-ABFD-BF95E4BDBF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7B1399F9-BD29-804C-8194-351EECD892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21300AD-ECC7-6446-B46C-CB46BB9984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6905CF-B80C-CC40-B8A8-3E567607DEA0}" type="datetimeFigureOut">
              <a:rPr lang="en-US" smtClean="0"/>
              <a:t>1/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5B586C6-D550-AC49-B77B-F70C3F18B3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D943B02-869D-7446-96F2-A3CB954F03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DE812-7233-5143-83BF-B2D833500F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99867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62F1E4E-0EF2-084C-83F9-F7156A123E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520A465A-8AB5-DB46-825B-2E09F5865ED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FDFB1558-0974-2F44-8CDC-3AE76C8A41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A2B47656-1A0A-E248-B7BB-340FD2E07E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6905CF-B80C-CC40-B8A8-3E567607DEA0}" type="datetimeFigureOut">
              <a:rPr lang="en-US" smtClean="0"/>
              <a:t>1/1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565FF1D4-5DFA-6841-BC48-F3463787CD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C2952FEC-A5F5-5747-BC2D-9F20E93EF9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DE812-7233-5143-83BF-B2D833500F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17651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2A254DD-DEA6-EC4E-96A4-06E59832CC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31EC55C0-5D16-3641-9109-52EF2A74BE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182D0684-105F-3D45-9E84-7FD05778F6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C4AD16CC-48DE-2B4C-9301-9EDFAC17416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A9C645AA-4075-204E-A2F7-7A3B8E64F8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481003E7-01D5-BA45-8BCD-80C03E6C8E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6905CF-B80C-CC40-B8A8-3E567607DEA0}" type="datetimeFigureOut">
              <a:rPr lang="en-US" smtClean="0"/>
              <a:t>1/1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35122DDE-AFB6-C744-A107-85EC2ABC14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4945C098-3899-7548-9E3D-EF052DA0E1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DE812-7233-5143-83BF-B2D833500F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622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A0559EC-F9D1-174C-8EC7-8A14DC20A7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93968B46-6E17-5440-8065-88B84049D9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6905CF-B80C-CC40-B8A8-3E567607DEA0}" type="datetimeFigureOut">
              <a:rPr lang="en-US" smtClean="0"/>
              <a:t>1/1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A45097F6-D42B-D742-8527-C7CD300943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F5812866-512C-AB40-AC88-C2C8BDE6B2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DE812-7233-5143-83BF-B2D833500F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4740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C6BE0382-FF83-214E-982F-DD389A2340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6905CF-B80C-CC40-B8A8-3E567607DEA0}" type="datetimeFigureOut">
              <a:rPr lang="en-US" smtClean="0"/>
              <a:t>1/1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C78C903D-96E4-3247-8823-559C98A8ED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F143E62C-8D67-464B-A001-75CC3CCE0A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DE812-7233-5143-83BF-B2D833500F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43506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C4BCD64-EAD8-0048-8438-393097B64B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833E9C40-A9F9-374E-A86D-F90E773C1A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68EAE64C-E333-304B-B1A0-D99C4AA350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E39B4C46-1470-E345-93D5-4767672555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6905CF-B80C-CC40-B8A8-3E567607DEA0}" type="datetimeFigureOut">
              <a:rPr lang="en-US" smtClean="0"/>
              <a:t>1/1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014809B7-681D-304F-95D9-9C420AAB6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3A349924-1B82-6E45-BE3E-9EE335BAB8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DE812-7233-5143-83BF-B2D833500F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60674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6B95309-82D4-854B-91A5-B78AADC14D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14970520-0A27-B247-8D40-ED86DB4FE22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F39E2FAD-09EC-7A4E-BC1A-397519D2BB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F0D46999-D26F-5E41-83FA-E8B67B39AE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6905CF-B80C-CC40-B8A8-3E567607DEA0}" type="datetimeFigureOut">
              <a:rPr lang="en-US" smtClean="0"/>
              <a:t>1/1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DE746D98-E995-A443-9532-FF81285F20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386EDF28-9402-754F-8B37-B55604431F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DE812-7233-5143-83BF-B2D833500F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173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FA19077D-BCC7-AF41-811F-1AD2652D7D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A1F1DEDC-1312-074B-B48B-186644E4EE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3DEBDA6-D042-D04F-ADF1-1E28A0FE525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6905CF-B80C-CC40-B8A8-3E567607DEA0}" type="datetimeFigureOut">
              <a:rPr lang="en-US" smtClean="0"/>
              <a:t>1/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BC3F99E-2147-374D-B62C-3F68AC8396B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363E3CF-35EF-114E-9893-6D20C590820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DDE812-7233-5143-83BF-B2D833500F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79325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89447" y="131032"/>
            <a:ext cx="12018886" cy="6660000"/>
            <a:chOff x="89447" y="131032"/>
            <a:chExt cx="12018886" cy="6660000"/>
          </a:xfrm>
        </p:grpSpPr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xmlns="" id="{AC5AFBA4-9DAA-424C-9EBB-596DF2A4018D}"/>
                </a:ext>
              </a:extLst>
            </p:cNvPr>
            <p:cNvSpPr/>
            <p:nvPr/>
          </p:nvSpPr>
          <p:spPr>
            <a:xfrm>
              <a:off x="4958888" y="131032"/>
              <a:ext cx="3528000" cy="66600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tx1">
                    <a:lumMod val="85000"/>
                    <a:lumOff val="15000"/>
                  </a:schemeClr>
                </a:solidFill>
              </a:endParaRP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xmlns="" id="{78EDA68F-2E68-D145-A8F9-B61F45313831}"/>
                </a:ext>
              </a:extLst>
            </p:cNvPr>
            <p:cNvSpPr/>
            <p:nvPr/>
          </p:nvSpPr>
          <p:spPr>
            <a:xfrm>
              <a:off x="8580333" y="131032"/>
              <a:ext cx="3528000" cy="6660000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tx1">
                    <a:lumMod val="85000"/>
                    <a:lumOff val="15000"/>
                  </a:schemeClr>
                </a:solidFill>
              </a:endParaRP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xmlns="" id="{4C3E13AC-3E38-1F44-B0EA-B4DFBF9D634F}"/>
                </a:ext>
              </a:extLst>
            </p:cNvPr>
            <p:cNvSpPr/>
            <p:nvPr/>
          </p:nvSpPr>
          <p:spPr>
            <a:xfrm>
              <a:off x="1318358" y="131032"/>
              <a:ext cx="3531600" cy="6660000"/>
            </a:xfrm>
            <a:prstGeom prst="rect">
              <a:avLst/>
            </a:prstGeom>
            <a:solidFill>
              <a:schemeClr val="accent2">
                <a:lumMod val="60000"/>
                <a:lumOff val="40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Gr</a:t>
              </a:r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xmlns="" id="{3247E103-FFD9-EB49-9AF8-8E511D391888}"/>
                </a:ext>
              </a:extLst>
            </p:cNvPr>
            <p:cNvSpPr/>
            <p:nvPr/>
          </p:nvSpPr>
          <p:spPr>
            <a:xfrm>
              <a:off x="5252280" y="2198113"/>
              <a:ext cx="1364969" cy="583624"/>
            </a:xfrm>
            <a:prstGeom prst="rect">
              <a:avLst/>
            </a:prstGeom>
            <a:solidFill>
              <a:schemeClr val="tx2">
                <a:lumMod val="20000"/>
                <a:lumOff val="80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CMR scan</a:t>
              </a:r>
            </a:p>
          </p:txBody>
        </p:sp>
        <p:sp>
          <p:nvSpPr>
            <p:cNvPr id="6" name="Oval 5">
              <a:extLst>
                <a:ext uri="{FF2B5EF4-FFF2-40B4-BE49-F238E27FC236}">
                  <a16:creationId xmlns:a16="http://schemas.microsoft.com/office/drawing/2014/main" xmlns="" id="{E586E749-DBE9-CD46-BEB9-F52E6488F43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528040" y="719216"/>
              <a:ext cx="1152000" cy="1152000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26</a:t>
              </a:r>
            </a:p>
            <a:p>
              <a:pPr algn="ctr"/>
              <a:r>
                <a:rPr lang="en-US" dirty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(50%)</a:t>
              </a:r>
            </a:p>
          </p:txBody>
        </p:sp>
        <p:sp>
          <p:nvSpPr>
            <p:cNvPr id="8" name="Oval 7">
              <a:extLst>
                <a:ext uri="{FF2B5EF4-FFF2-40B4-BE49-F238E27FC236}">
                  <a16:creationId xmlns:a16="http://schemas.microsoft.com/office/drawing/2014/main" xmlns="" id="{401C306D-292D-B249-B99C-9959B1409431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156125" y="716974"/>
              <a:ext cx="1152000" cy="1152000"/>
            </a:xfrm>
            <a:prstGeom prst="ellipse">
              <a:avLst/>
            </a:prstGeom>
            <a:solidFill>
              <a:schemeClr val="accent2">
                <a:lumMod val="40000"/>
                <a:lumOff val="60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26 (50%)</a:t>
              </a:r>
            </a:p>
          </p:txBody>
        </p:sp>
        <p:sp>
          <p:nvSpPr>
            <p:cNvPr id="11" name="Oval 10">
              <a:extLst>
                <a:ext uri="{FF2B5EF4-FFF2-40B4-BE49-F238E27FC236}">
                  <a16:creationId xmlns:a16="http://schemas.microsoft.com/office/drawing/2014/main" xmlns="" id="{4F9C39E9-1538-E74E-A29B-206FA66AF9E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528040" y="5415805"/>
              <a:ext cx="1152000" cy="1152000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6</a:t>
              </a:r>
            </a:p>
            <a:p>
              <a:pPr algn="ctr"/>
              <a:r>
                <a:rPr lang="en-US" sz="1600" dirty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(11.5%)</a:t>
              </a:r>
            </a:p>
          </p:txBody>
        </p:sp>
        <p:sp>
          <p:nvSpPr>
            <p:cNvPr id="12" name="Oval 11">
              <a:extLst>
                <a:ext uri="{FF2B5EF4-FFF2-40B4-BE49-F238E27FC236}">
                  <a16:creationId xmlns:a16="http://schemas.microsoft.com/office/drawing/2014/main" xmlns="" id="{B8E30693-B5FA-CF4C-B2EF-7BF407BD8D03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157063" y="5415805"/>
              <a:ext cx="1152000" cy="1152000"/>
            </a:xfrm>
            <a:prstGeom prst="ellipse">
              <a:avLst/>
            </a:prstGeom>
            <a:solidFill>
              <a:schemeClr val="accent2">
                <a:lumMod val="40000"/>
                <a:lumOff val="60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27 </a:t>
              </a:r>
              <a:r>
                <a:rPr lang="en-US" sz="1600" dirty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(52%)</a:t>
              </a: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xmlns="" id="{F75C85E0-AE66-864E-B457-C3C478519959}"/>
                </a:ext>
              </a:extLst>
            </p:cNvPr>
            <p:cNvSpPr/>
            <p:nvPr/>
          </p:nvSpPr>
          <p:spPr>
            <a:xfrm>
              <a:off x="1457611" y="3396344"/>
              <a:ext cx="900000" cy="900000"/>
            </a:xfrm>
            <a:prstGeom prst="rect">
              <a:avLst/>
            </a:prstGeom>
            <a:solidFill>
              <a:schemeClr val="accent2">
                <a:lumMod val="60000"/>
                <a:lumOff val="40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6   (11.5%)</a:t>
              </a: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xmlns="" id="{E4392F95-8664-BC47-9F47-D25EA7B3716E}"/>
                </a:ext>
              </a:extLst>
            </p:cNvPr>
            <p:cNvSpPr/>
            <p:nvPr/>
          </p:nvSpPr>
          <p:spPr>
            <a:xfrm>
              <a:off x="2654314" y="3396344"/>
              <a:ext cx="900000" cy="9000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13 (25%)</a:t>
              </a: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xmlns="" id="{E31249EF-51F9-A343-B307-FB0233F434F4}"/>
                </a:ext>
              </a:extLst>
            </p:cNvPr>
            <p:cNvSpPr/>
            <p:nvPr/>
          </p:nvSpPr>
          <p:spPr>
            <a:xfrm>
              <a:off x="3819306" y="3396344"/>
              <a:ext cx="900000" cy="900000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7  (13.5%)</a:t>
              </a: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xmlns="" id="{A2D9F99C-F081-4E41-97DA-C37A170E6148}"/>
                </a:ext>
              </a:extLst>
            </p:cNvPr>
            <p:cNvSpPr/>
            <p:nvPr/>
          </p:nvSpPr>
          <p:spPr>
            <a:xfrm>
              <a:off x="5100928" y="3396344"/>
              <a:ext cx="900000" cy="900000"/>
            </a:xfrm>
            <a:prstGeom prst="rect">
              <a:avLst/>
            </a:prstGeom>
            <a:solidFill>
              <a:schemeClr val="accent2">
                <a:lumMod val="60000"/>
                <a:lumOff val="40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0    (0%)</a:t>
              </a: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xmlns="" id="{E7ADA11F-FC37-A54C-8D10-911BE9CDA6BF}"/>
                </a:ext>
              </a:extLst>
            </p:cNvPr>
            <p:cNvSpPr/>
            <p:nvPr/>
          </p:nvSpPr>
          <p:spPr>
            <a:xfrm>
              <a:off x="6297631" y="3396344"/>
              <a:ext cx="900000" cy="9000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14 (27%)</a:t>
              </a:r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xmlns="" id="{F9C24171-A3A9-1A42-A859-2E3714D95345}"/>
                </a:ext>
              </a:extLst>
            </p:cNvPr>
            <p:cNvSpPr/>
            <p:nvPr/>
          </p:nvSpPr>
          <p:spPr>
            <a:xfrm>
              <a:off x="7462623" y="3396344"/>
              <a:ext cx="900000" cy="900000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12 (23%)</a:t>
              </a:r>
            </a:p>
          </p:txBody>
        </p: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xmlns="" id="{ED14ED95-9927-F64B-8976-5196190C1AEF}"/>
                </a:ext>
              </a:extLst>
            </p:cNvPr>
            <p:cNvCxnSpPr>
              <a:stCxn id="6" idx="4"/>
              <a:endCxn id="25" idx="0"/>
            </p:cNvCxnSpPr>
            <p:nvPr/>
          </p:nvCxnSpPr>
          <p:spPr>
            <a:xfrm>
              <a:off x="3104040" y="1871216"/>
              <a:ext cx="274" cy="1525128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xmlns="" id="{4BF4FF31-DC52-DB4E-8915-C5E6864D48AB}"/>
                </a:ext>
              </a:extLst>
            </p:cNvPr>
            <p:cNvCxnSpPr>
              <a:cxnSpLocks/>
            </p:cNvCxnSpPr>
            <p:nvPr/>
          </p:nvCxnSpPr>
          <p:spPr>
            <a:xfrm>
              <a:off x="4269306" y="2909456"/>
              <a:ext cx="0" cy="486000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xmlns="" id="{DD8E7521-0E84-E34C-8B83-2A64FFECCEB2}"/>
                </a:ext>
              </a:extLst>
            </p:cNvPr>
            <p:cNvCxnSpPr>
              <a:cxnSpLocks/>
            </p:cNvCxnSpPr>
            <p:nvPr/>
          </p:nvCxnSpPr>
          <p:spPr>
            <a:xfrm>
              <a:off x="1914620" y="2909455"/>
              <a:ext cx="0" cy="486886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xmlns="" id="{23E8BC33-7452-1B47-9E04-4BE6CED5D18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901223" y="2909455"/>
              <a:ext cx="2383200" cy="0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xmlns="" id="{63687E92-A045-B541-9B05-BD42782E9FE5}"/>
                </a:ext>
              </a:extLst>
            </p:cNvPr>
            <p:cNvCxnSpPr>
              <a:cxnSpLocks/>
            </p:cNvCxnSpPr>
            <p:nvPr/>
          </p:nvCxnSpPr>
          <p:spPr>
            <a:xfrm>
              <a:off x="7897506" y="2909456"/>
              <a:ext cx="0" cy="486000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xmlns="" id="{7F4C9573-D368-AC40-9D6C-B43FCA942119}"/>
                </a:ext>
              </a:extLst>
            </p:cNvPr>
            <p:cNvCxnSpPr>
              <a:cxnSpLocks/>
            </p:cNvCxnSpPr>
            <p:nvPr/>
          </p:nvCxnSpPr>
          <p:spPr>
            <a:xfrm>
              <a:off x="5542820" y="2909455"/>
              <a:ext cx="0" cy="486886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xmlns="" id="{5E7E9CCB-CFD0-5841-9AC3-BD2A0EEBFF8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29423" y="2909455"/>
              <a:ext cx="2383200" cy="0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xmlns="" id="{620411FC-6496-FC46-AFF8-F1659E1C5CC4}"/>
                </a:ext>
              </a:extLst>
            </p:cNvPr>
            <p:cNvCxnSpPr>
              <a:cxnSpLocks/>
              <a:stCxn id="8" idx="4"/>
            </p:cNvCxnSpPr>
            <p:nvPr/>
          </p:nvCxnSpPr>
          <p:spPr>
            <a:xfrm>
              <a:off x="6732125" y="1868974"/>
              <a:ext cx="14411" cy="1511505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xmlns="" id="{5015BC7E-3661-A44E-8189-1DFC212EFF44}"/>
                </a:ext>
              </a:extLst>
            </p:cNvPr>
            <p:cNvCxnSpPr>
              <a:cxnSpLocks/>
            </p:cNvCxnSpPr>
            <p:nvPr/>
          </p:nvCxnSpPr>
          <p:spPr>
            <a:xfrm>
              <a:off x="1907532" y="4310520"/>
              <a:ext cx="0" cy="558000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xmlns="" id="{9CF34A82-CC5F-D847-9BF9-630CC1D5BE11}"/>
                </a:ext>
              </a:extLst>
            </p:cNvPr>
            <p:cNvCxnSpPr>
              <a:cxnSpLocks/>
            </p:cNvCxnSpPr>
            <p:nvPr/>
          </p:nvCxnSpPr>
          <p:spPr>
            <a:xfrm>
              <a:off x="3097584" y="4865497"/>
              <a:ext cx="0" cy="540000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xmlns="" id="{B1DD4562-F4FB-5949-9D06-C97A9361111A}"/>
                </a:ext>
              </a:extLst>
            </p:cNvPr>
            <p:cNvCxnSpPr>
              <a:cxnSpLocks/>
            </p:cNvCxnSpPr>
            <p:nvPr/>
          </p:nvCxnSpPr>
          <p:spPr>
            <a:xfrm>
              <a:off x="1898085" y="4858477"/>
              <a:ext cx="1213200" cy="0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xmlns="" id="{12472B53-1110-3E4F-AA3C-B2284A1FB2CE}"/>
                </a:ext>
              </a:extLst>
            </p:cNvPr>
            <p:cNvCxnSpPr>
              <a:cxnSpLocks/>
            </p:cNvCxnSpPr>
            <p:nvPr/>
          </p:nvCxnSpPr>
          <p:spPr>
            <a:xfrm>
              <a:off x="4269306" y="4303223"/>
              <a:ext cx="0" cy="280800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58">
              <a:extLst>
                <a:ext uri="{FF2B5EF4-FFF2-40B4-BE49-F238E27FC236}">
                  <a16:creationId xmlns:a16="http://schemas.microsoft.com/office/drawing/2014/main" xmlns="" id="{0444392D-BF2A-7947-8405-C71826988EF1}"/>
                </a:ext>
              </a:extLst>
            </p:cNvPr>
            <p:cNvCxnSpPr>
              <a:cxnSpLocks/>
            </p:cNvCxnSpPr>
            <p:nvPr/>
          </p:nvCxnSpPr>
          <p:spPr>
            <a:xfrm>
              <a:off x="3099005" y="4288227"/>
              <a:ext cx="1353" cy="442800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xmlns="" id="{C9AC7D1D-EEDC-F747-951F-5800E5F77247}"/>
                </a:ext>
              </a:extLst>
            </p:cNvPr>
            <p:cNvCxnSpPr>
              <a:cxnSpLocks/>
            </p:cNvCxnSpPr>
            <p:nvPr/>
          </p:nvCxnSpPr>
          <p:spPr>
            <a:xfrm>
              <a:off x="6606616" y="4702422"/>
              <a:ext cx="0" cy="712800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xmlns="" id="{BF5969E4-EECC-544D-9842-517B91AA6271}"/>
                </a:ext>
              </a:extLst>
            </p:cNvPr>
            <p:cNvCxnSpPr>
              <a:cxnSpLocks/>
            </p:cNvCxnSpPr>
            <p:nvPr/>
          </p:nvCxnSpPr>
          <p:spPr>
            <a:xfrm>
              <a:off x="4266131" y="4568157"/>
              <a:ext cx="6044400" cy="0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xmlns="" id="{8F3BBBB3-9AD9-4A4B-B275-A81FBC86448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299734" y="4556222"/>
              <a:ext cx="0" cy="853200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Oval 64">
              <a:extLst>
                <a:ext uri="{FF2B5EF4-FFF2-40B4-BE49-F238E27FC236}">
                  <a16:creationId xmlns:a16="http://schemas.microsoft.com/office/drawing/2014/main" xmlns="" id="{893381F7-F64E-7E48-8F7C-12EBA04A8738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9787448" y="5415805"/>
              <a:ext cx="1152000" cy="1152000"/>
            </a:xfrm>
            <a:prstGeom prst="ellipse">
              <a:avLst/>
            </a:prstGeom>
            <a:solidFill>
              <a:schemeClr val="accent4">
                <a:lumMod val="20000"/>
                <a:lumOff val="80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19 </a:t>
              </a:r>
              <a:r>
                <a:rPr lang="en-US" sz="1600" dirty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(36.5%)</a:t>
              </a:r>
            </a:p>
          </p:txBody>
        </p: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xmlns="" id="{6F3F1486-717A-1340-951A-1DF4AF74860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95998" y="4715251"/>
              <a:ext cx="3520800" cy="2756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xmlns="" id="{8644AE38-A0EE-1C49-AB58-A8DD594DE5F6}"/>
                </a:ext>
              </a:extLst>
            </p:cNvPr>
            <p:cNvCxnSpPr>
              <a:cxnSpLocks/>
            </p:cNvCxnSpPr>
            <p:nvPr/>
          </p:nvCxnSpPr>
          <p:spPr>
            <a:xfrm>
              <a:off x="6747631" y="4302694"/>
              <a:ext cx="0" cy="1107185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xmlns="" id="{966FAF15-F7CD-E04E-AB6A-3CCB60C9F858}"/>
                </a:ext>
              </a:extLst>
            </p:cNvPr>
            <p:cNvCxnSpPr>
              <a:cxnSpLocks/>
            </p:cNvCxnSpPr>
            <p:nvPr/>
          </p:nvCxnSpPr>
          <p:spPr>
            <a:xfrm>
              <a:off x="10441856" y="4411506"/>
              <a:ext cx="0" cy="997200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>
              <a:extLst>
                <a:ext uri="{FF2B5EF4-FFF2-40B4-BE49-F238E27FC236}">
                  <a16:creationId xmlns:a16="http://schemas.microsoft.com/office/drawing/2014/main" xmlns="" id="{77F8A66C-DCA2-644B-BEA7-214503F2EF63}"/>
                </a:ext>
              </a:extLst>
            </p:cNvPr>
            <p:cNvCxnSpPr>
              <a:cxnSpLocks/>
            </p:cNvCxnSpPr>
            <p:nvPr/>
          </p:nvCxnSpPr>
          <p:spPr>
            <a:xfrm>
              <a:off x="7915921" y="4296344"/>
              <a:ext cx="0" cy="110557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Straight Connector 83">
              <a:extLst>
                <a:ext uri="{FF2B5EF4-FFF2-40B4-BE49-F238E27FC236}">
                  <a16:creationId xmlns:a16="http://schemas.microsoft.com/office/drawing/2014/main" xmlns="" id="{9E4F0969-1A2F-6747-80F2-838E0E7FF03A}"/>
                </a:ext>
              </a:extLst>
            </p:cNvPr>
            <p:cNvCxnSpPr>
              <a:cxnSpLocks/>
            </p:cNvCxnSpPr>
            <p:nvPr/>
          </p:nvCxnSpPr>
          <p:spPr>
            <a:xfrm>
              <a:off x="7903856" y="4423833"/>
              <a:ext cx="2545200" cy="0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Rectangle 88">
              <a:extLst>
                <a:ext uri="{FF2B5EF4-FFF2-40B4-BE49-F238E27FC236}">
                  <a16:creationId xmlns:a16="http://schemas.microsoft.com/office/drawing/2014/main" xmlns="" id="{8BE9FD79-CD40-A64A-873A-CD88C81863D8}"/>
                </a:ext>
              </a:extLst>
            </p:cNvPr>
            <p:cNvSpPr/>
            <p:nvPr/>
          </p:nvSpPr>
          <p:spPr>
            <a:xfrm>
              <a:off x="1617617" y="2198113"/>
              <a:ext cx="1364969" cy="583624"/>
            </a:xfrm>
            <a:prstGeom prst="rect">
              <a:avLst/>
            </a:prstGeom>
            <a:solidFill>
              <a:schemeClr val="tx2">
                <a:lumMod val="20000"/>
                <a:lumOff val="80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CMR scan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xmlns="" id="{5534AA17-7909-F549-BC7C-0D5A19181B1E}"/>
                </a:ext>
              </a:extLst>
            </p:cNvPr>
            <p:cNvSpPr txBox="1"/>
            <p:nvPr/>
          </p:nvSpPr>
          <p:spPr>
            <a:xfrm>
              <a:off x="1457611" y="254904"/>
              <a:ext cx="139802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Grounded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xmlns="" id="{780CE789-2C52-3648-942A-3763914B220B}"/>
                </a:ext>
              </a:extLst>
            </p:cNvPr>
            <p:cNvSpPr txBox="1"/>
            <p:nvPr/>
          </p:nvSpPr>
          <p:spPr>
            <a:xfrm>
              <a:off x="5100928" y="216246"/>
              <a:ext cx="139802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Restricted</a:t>
              </a:r>
              <a:r>
                <a:rPr lang="en-US" dirty="0"/>
                <a:t> </a:t>
              </a:r>
              <a:r>
                <a:rPr lang="en-US" b="1" dirty="0"/>
                <a:t>Flying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xmlns="" id="{5BB1D39B-428A-0748-A605-858EB2309D7E}"/>
                </a:ext>
              </a:extLst>
            </p:cNvPr>
            <p:cNvSpPr txBox="1"/>
            <p:nvPr/>
          </p:nvSpPr>
          <p:spPr>
            <a:xfrm>
              <a:off x="8749943" y="254904"/>
              <a:ext cx="139802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Unrestricted</a:t>
              </a:r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xmlns="" id="{26F4025E-D0A8-4440-AA8B-DFD965127233}"/>
                </a:ext>
              </a:extLst>
            </p:cNvPr>
            <p:cNvSpPr/>
            <p:nvPr/>
          </p:nvSpPr>
          <p:spPr>
            <a:xfrm>
              <a:off x="92641" y="131032"/>
              <a:ext cx="1132271" cy="1527647"/>
            </a:xfrm>
            <a:prstGeom prst="rect">
              <a:avLst/>
            </a:prstGeom>
            <a:solidFill>
              <a:schemeClr val="tx2">
                <a:lumMod val="20000"/>
                <a:lumOff val="80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Flying status after standard care</a:t>
              </a: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xmlns="" id="{AE3114BB-0512-EC44-BA5E-B6F2815D0B02}"/>
                </a:ext>
              </a:extLst>
            </p:cNvPr>
            <p:cNvSpPr/>
            <p:nvPr/>
          </p:nvSpPr>
          <p:spPr>
            <a:xfrm>
              <a:off x="92641" y="5263385"/>
              <a:ext cx="1132271" cy="1527647"/>
            </a:xfrm>
            <a:prstGeom prst="rect">
              <a:avLst/>
            </a:prstGeom>
            <a:solidFill>
              <a:schemeClr val="tx2">
                <a:lumMod val="20000"/>
                <a:lumOff val="80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Flying status after addition of CMR</a:t>
              </a:r>
            </a:p>
          </p:txBody>
        </p: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xmlns="" id="{0F48B3CE-6CF0-BB48-9A3C-B2D2590B1C39}"/>
                </a:ext>
              </a:extLst>
            </p:cNvPr>
            <p:cNvCxnSpPr>
              <a:cxnSpLocks/>
              <a:endCxn id="46" idx="0"/>
            </p:cNvCxnSpPr>
            <p:nvPr/>
          </p:nvCxnSpPr>
          <p:spPr>
            <a:xfrm>
              <a:off x="656447" y="1674663"/>
              <a:ext cx="0" cy="523450"/>
            </a:xfrm>
            <a:prstGeom prst="line">
              <a:avLst/>
            </a:prstGeom>
            <a:ln w="28575">
              <a:solidFill>
                <a:schemeClr val="tx1"/>
              </a:solidFill>
              <a:prstDash val="sysDash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xmlns="" id="{7F48D586-9E9A-7F40-806B-5472C78DDA87}"/>
                </a:ext>
              </a:extLst>
            </p:cNvPr>
            <p:cNvSpPr/>
            <p:nvPr/>
          </p:nvSpPr>
          <p:spPr>
            <a:xfrm>
              <a:off x="89447" y="2198113"/>
              <a:ext cx="1134000" cy="583624"/>
            </a:xfrm>
            <a:prstGeom prst="rect">
              <a:avLst/>
            </a:prstGeom>
            <a:solidFill>
              <a:schemeClr val="tx2">
                <a:lumMod val="20000"/>
                <a:lumOff val="80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CMR</a:t>
              </a:r>
            </a:p>
          </p:txBody>
        </p: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xmlns="" id="{44E8056A-8BD2-C748-8F2E-B406501F79CA}"/>
                </a:ext>
              </a:extLst>
            </p:cNvPr>
            <p:cNvCxnSpPr>
              <a:cxnSpLocks/>
              <a:stCxn id="46" idx="2"/>
              <a:endCxn id="43" idx="0"/>
            </p:cNvCxnSpPr>
            <p:nvPr/>
          </p:nvCxnSpPr>
          <p:spPr>
            <a:xfrm>
              <a:off x="656447" y="2781737"/>
              <a:ext cx="2330" cy="2481648"/>
            </a:xfrm>
            <a:prstGeom prst="line">
              <a:avLst/>
            </a:prstGeom>
            <a:ln w="28575">
              <a:solidFill>
                <a:schemeClr val="tx1"/>
              </a:solidFill>
              <a:prstDash val="sysDash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9486655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5</Words>
  <Application>Microsoft Office PowerPoint</Application>
  <PresentationFormat>Custom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Holdsworth</dc:creator>
  <cp:lastModifiedBy>Windows User</cp:lastModifiedBy>
  <cp:revision>1</cp:revision>
  <dcterms:created xsi:type="dcterms:W3CDTF">2019-01-01T12:14:29Z</dcterms:created>
  <dcterms:modified xsi:type="dcterms:W3CDTF">2019-01-01T12:16:35Z</dcterms:modified>
</cp:coreProperties>
</file>